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4D0140-50FB-4AAF-838F-446F8ADED1F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BF48D2-AB5E-4937-B53A-FD7A1807C91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F29A44-4286-4874-A291-D6AB1FAD525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14170C-2FED-4691-BCFB-10E13A18309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41381A-B47C-4D98-AD5A-A6A0766A17D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234BC9-9FA8-45E7-88AE-D562C0427CF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68C083-AD27-4D01-885A-BFACCA367D8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C1BF1F-5D5C-4E46-B543-388C41D5A7E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36CE1D-B75B-4CDB-8A68-82E4E1DF12F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844BFE-021C-43CF-9A83-FB49A1F499A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C6B8C8-0EEB-47FD-AD0F-B7FBD44F42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51C653-BBFC-40DC-87C7-1C6CE108CF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AB580F4-5FD5-4FC3-8233-0BBF871F2F15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342720" y="396720"/>
            <a:ext cx="6172200" cy="110016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2. Improvement in correlation between serum leptin and adipose tissue when a) adjusted to central fat mass compared to b) secretion per 100mg adipose tissue.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Pearson’s (R) correlation coefficients and significance (p-values) shown,  n = 24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Chart 10" descr=""/>
          <p:cNvPicPr/>
          <p:nvPr/>
        </p:nvPicPr>
        <p:blipFill>
          <a:blip r:embed="rId1"/>
          <a:stretch/>
        </p:blipFill>
        <p:spPr>
          <a:xfrm>
            <a:off x="1407960" y="1347840"/>
            <a:ext cx="3754440" cy="4041720"/>
          </a:xfrm>
          <a:prstGeom prst="rect">
            <a:avLst/>
          </a:prstGeom>
          <a:ln w="0">
            <a:noFill/>
          </a:ln>
        </p:spPr>
      </p:pic>
      <p:sp>
        <p:nvSpPr>
          <p:cNvPr id="43" name="TextBox 11"/>
          <p:cNvSpPr/>
          <p:nvPr/>
        </p:nvSpPr>
        <p:spPr>
          <a:xfrm>
            <a:off x="1204560" y="1857240"/>
            <a:ext cx="35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a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12"/>
          <p:cNvSpPr/>
          <p:nvPr/>
        </p:nvSpPr>
        <p:spPr>
          <a:xfrm>
            <a:off x="2789640" y="2027160"/>
            <a:ext cx="13039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R=0.875, </a:t>
            </a:r>
            <a:r>
              <a:rPr b="0" i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p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&lt;0.00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5" name="Chart 13" descr=""/>
          <p:cNvPicPr/>
          <p:nvPr/>
        </p:nvPicPr>
        <p:blipFill>
          <a:blip r:embed="rId2"/>
          <a:stretch/>
        </p:blipFill>
        <p:spPr>
          <a:xfrm>
            <a:off x="1322280" y="5450040"/>
            <a:ext cx="3902040" cy="3754440"/>
          </a:xfrm>
          <a:prstGeom prst="rect">
            <a:avLst/>
          </a:prstGeom>
          <a:ln w="0">
            <a:noFill/>
          </a:ln>
        </p:spPr>
      </p:pic>
      <p:sp>
        <p:nvSpPr>
          <p:cNvPr id="46" name="TextBox 14"/>
          <p:cNvSpPr/>
          <p:nvPr/>
        </p:nvSpPr>
        <p:spPr>
          <a:xfrm>
            <a:off x="1191240" y="5880240"/>
            <a:ext cx="369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b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15"/>
          <p:cNvSpPr/>
          <p:nvPr/>
        </p:nvSpPr>
        <p:spPr>
          <a:xfrm>
            <a:off x="2832480" y="5987880"/>
            <a:ext cx="13039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R=0.640, </a:t>
            </a:r>
            <a:r>
              <a:rPr b="0" i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p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=0.00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5-22T11:13:51Z</dcterms:created>
  <dc:creator>Rebecca Travers</dc:creator>
  <dc:description/>
  <dc:language>en-US</dc:language>
  <cp:lastModifiedBy>ravikumar.n</cp:lastModifiedBy>
  <dcterms:modified xsi:type="dcterms:W3CDTF">2014-12-16T22:38:59Z</dcterms:modified>
  <cp:revision>5</cp:revision>
  <dc:subject/>
  <dc:title>Supplementary figure 3. Correlations between waist circumference and activation status of blood CD4+ and CD8+  T-Lymphocyte populations a) – d). Pearson’s (R) correlation coefficients and significance (p-values) shown, n=30. MFI denotes mean fluorescence intensity.</dc:title>
</cp:coreProperties>
</file>